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85" d="100"/>
          <a:sy n="85" d="100"/>
        </p:scale>
        <p:origin x="-528" y="7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zhangzilian:Desktop:S2%20FIg&#8722;2015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3!$B$6</c:f>
              <c:strCache>
                <c:ptCount val="1"/>
                <c:pt idx="0">
                  <c:v>Actinobacteria</c:v>
                </c:pt>
              </c:strCache>
            </c:strRef>
          </c:tx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6:$N$6</c:f>
              <c:numCache>
                <c:formatCode>General</c:formatCode>
                <c:ptCount val="12"/>
                <c:pt idx="0">
                  <c:v>6.093145725339999</c:v>
                </c:pt>
                <c:pt idx="1">
                  <c:v>2.57009973923</c:v>
                </c:pt>
                <c:pt idx="2">
                  <c:v>1.73209575979</c:v>
                </c:pt>
                <c:pt idx="3">
                  <c:v>0.689347035169</c:v>
                </c:pt>
                <c:pt idx="4">
                  <c:v>1.09006493288</c:v>
                </c:pt>
                <c:pt idx="5">
                  <c:v>0.539275003946</c:v>
                </c:pt>
                <c:pt idx="6">
                  <c:v>1.07817897771</c:v>
                </c:pt>
                <c:pt idx="7">
                  <c:v>0.513080571548</c:v>
                </c:pt>
                <c:pt idx="8">
                  <c:v>0.600388023701</c:v>
                </c:pt>
                <c:pt idx="9">
                  <c:v>3.890641430069997</c:v>
                </c:pt>
                <c:pt idx="10">
                  <c:v>1.51955019844</c:v>
                </c:pt>
                <c:pt idx="11">
                  <c:v>3.75839410788</c:v>
                </c:pt>
              </c:numCache>
            </c:numRef>
          </c:val>
        </c:ser>
        <c:ser>
          <c:idx val="1"/>
          <c:order val="1"/>
          <c:tx>
            <c:strRef>
              <c:f>Sheet3!$B$7</c:f>
              <c:strCache>
                <c:ptCount val="1"/>
                <c:pt idx="0">
                  <c:v>Bacteroidetes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7:$N$7</c:f>
              <c:numCache>
                <c:formatCode>General</c:formatCode>
                <c:ptCount val="12"/>
                <c:pt idx="0">
                  <c:v>25.9586110425</c:v>
                </c:pt>
                <c:pt idx="1">
                  <c:v>67.2661773799</c:v>
                </c:pt>
                <c:pt idx="2">
                  <c:v>56.37046053969997</c:v>
                </c:pt>
                <c:pt idx="3">
                  <c:v>7.48388332163</c:v>
                </c:pt>
                <c:pt idx="4">
                  <c:v>8.70369747334</c:v>
                </c:pt>
                <c:pt idx="5">
                  <c:v>5.653180407219995</c:v>
                </c:pt>
                <c:pt idx="6">
                  <c:v>13.5124430655</c:v>
                </c:pt>
                <c:pt idx="7">
                  <c:v>52.6534021418</c:v>
                </c:pt>
                <c:pt idx="8">
                  <c:v>31.6422840963</c:v>
                </c:pt>
                <c:pt idx="9">
                  <c:v>32.57389882</c:v>
                </c:pt>
                <c:pt idx="10">
                  <c:v>28.2283551374</c:v>
                </c:pt>
                <c:pt idx="11">
                  <c:v>36.6235829302</c:v>
                </c:pt>
              </c:numCache>
            </c:numRef>
          </c:val>
        </c:ser>
        <c:ser>
          <c:idx val="2"/>
          <c:order val="2"/>
          <c:tx>
            <c:strRef>
              <c:f>Sheet3!$B$8</c:f>
              <c:strCache>
                <c:ptCount val="1"/>
                <c:pt idx="0">
                  <c:v>Planctomycetes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</c:spPr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8:$N$8</c:f>
              <c:numCache>
                <c:formatCode>General</c:formatCode>
                <c:ptCount val="12"/>
                <c:pt idx="0">
                  <c:v>1.53460051016</c:v>
                </c:pt>
                <c:pt idx="1">
                  <c:v>1.18557948222</c:v>
                </c:pt>
                <c:pt idx="2">
                  <c:v>1.13866910124</c:v>
                </c:pt>
                <c:pt idx="3">
                  <c:v>0.5776472841</c:v>
                </c:pt>
                <c:pt idx="4">
                  <c:v>0.629142414965</c:v>
                </c:pt>
                <c:pt idx="5">
                  <c:v>0.670805492713</c:v>
                </c:pt>
                <c:pt idx="6">
                  <c:v>4.057473540609997</c:v>
                </c:pt>
                <c:pt idx="7">
                  <c:v>6.03466276885</c:v>
                </c:pt>
                <c:pt idx="8">
                  <c:v>19.4247810812</c:v>
                </c:pt>
                <c:pt idx="9">
                  <c:v>5.08236943568</c:v>
                </c:pt>
                <c:pt idx="10">
                  <c:v>8.130604145229998</c:v>
                </c:pt>
                <c:pt idx="11">
                  <c:v>4.90649144343</c:v>
                </c:pt>
              </c:numCache>
            </c:numRef>
          </c:val>
        </c:ser>
        <c:ser>
          <c:idx val="3"/>
          <c:order val="3"/>
          <c:tx>
            <c:strRef>
              <c:f>Sheet3!$B$9</c:f>
              <c:strCache>
                <c:ptCount val="1"/>
                <c:pt idx="0">
                  <c:v>Proteobacteria</c:v>
                </c:pt>
              </c:strCache>
            </c:strRef>
          </c:tx>
          <c:spPr>
            <a:solidFill>
              <a:srgbClr val="0000FF"/>
            </a:solidFill>
          </c:spPr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9:$N$9</c:f>
              <c:numCache>
                <c:formatCode>General</c:formatCode>
                <c:ptCount val="12"/>
                <c:pt idx="0">
                  <c:v>55.1016209989</c:v>
                </c:pt>
                <c:pt idx="1">
                  <c:v>19.6574992607</c:v>
                </c:pt>
                <c:pt idx="2">
                  <c:v>34.5709068777</c:v>
                </c:pt>
                <c:pt idx="3">
                  <c:v>89.2385268399</c:v>
                </c:pt>
                <c:pt idx="4">
                  <c:v>86.76782289809998</c:v>
                </c:pt>
                <c:pt idx="5">
                  <c:v>91.2742673752</c:v>
                </c:pt>
                <c:pt idx="6">
                  <c:v>74.4713622461</c:v>
                </c:pt>
                <c:pt idx="7">
                  <c:v>31.7453688512</c:v>
                </c:pt>
                <c:pt idx="8">
                  <c:v>42.5960883016</c:v>
                </c:pt>
                <c:pt idx="9">
                  <c:v>50.4498189041</c:v>
                </c:pt>
                <c:pt idx="10">
                  <c:v>34.5196971924</c:v>
                </c:pt>
                <c:pt idx="11">
                  <c:v>39.35482706329994</c:v>
                </c:pt>
              </c:numCache>
            </c:numRef>
          </c:val>
        </c:ser>
        <c:ser>
          <c:idx val="4"/>
          <c:order val="4"/>
          <c:tx>
            <c:strRef>
              <c:f>Sheet3!$B$10</c:f>
              <c:strCache>
                <c:ptCount val="1"/>
                <c:pt idx="0">
                  <c:v>Unclassified Bacteri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</c:spPr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10:$N$10</c:f>
              <c:numCache>
                <c:formatCode>General</c:formatCode>
                <c:ptCount val="12"/>
                <c:pt idx="0">
                  <c:v>8.61721385666</c:v>
                </c:pt>
                <c:pt idx="1">
                  <c:v>5.352582197489997</c:v>
                </c:pt>
                <c:pt idx="2">
                  <c:v>1.54189490769</c:v>
                </c:pt>
                <c:pt idx="3">
                  <c:v>1.30848279824</c:v>
                </c:pt>
                <c:pt idx="4">
                  <c:v>1.96817279548</c:v>
                </c:pt>
                <c:pt idx="5">
                  <c:v>1.23375598464</c:v>
                </c:pt>
                <c:pt idx="6">
                  <c:v>4.83200211235</c:v>
                </c:pt>
                <c:pt idx="7">
                  <c:v>4.40294723026</c:v>
                </c:pt>
                <c:pt idx="8">
                  <c:v>4.70347648262</c:v>
                </c:pt>
                <c:pt idx="9">
                  <c:v>7.24967870078</c:v>
                </c:pt>
                <c:pt idx="10">
                  <c:v>25.48324268699997</c:v>
                </c:pt>
                <c:pt idx="11">
                  <c:v>13.0334320168</c:v>
                </c:pt>
              </c:numCache>
            </c:numRef>
          </c:val>
        </c:ser>
        <c:ser>
          <c:idx val="5"/>
          <c:order val="5"/>
          <c:tx>
            <c:strRef>
              <c:f>Sheet3!$B$11</c:f>
              <c:strCache>
                <c:ptCount val="1"/>
                <c:pt idx="0">
                  <c:v>Verrucomicrobia</c:v>
                </c:pt>
              </c:strCache>
            </c:strRef>
          </c:tx>
          <c:spPr>
            <a:solidFill>
              <a:srgbClr val="008000"/>
            </a:solidFill>
          </c:spPr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11:$N$11</c:f>
              <c:numCache>
                <c:formatCode>General</c:formatCode>
                <c:ptCount val="12"/>
                <c:pt idx="0">
                  <c:v>1.81848103349</c:v>
                </c:pt>
                <c:pt idx="1">
                  <c:v>3.5540500578</c:v>
                </c:pt>
                <c:pt idx="2">
                  <c:v>3.96885778048</c:v>
                </c:pt>
                <c:pt idx="3">
                  <c:v>0.465947533031</c:v>
                </c:pt>
                <c:pt idx="4">
                  <c:v>0.484473303502</c:v>
                </c:pt>
                <c:pt idx="5">
                  <c:v>0.476140369338</c:v>
                </c:pt>
                <c:pt idx="6">
                  <c:v>1.60186590974</c:v>
                </c:pt>
                <c:pt idx="7">
                  <c:v>4.23888076843</c:v>
                </c:pt>
                <c:pt idx="8">
                  <c:v>0.448324681454</c:v>
                </c:pt>
                <c:pt idx="9">
                  <c:v>0.441056198154</c:v>
                </c:pt>
                <c:pt idx="10">
                  <c:v>1.78597677495</c:v>
                </c:pt>
                <c:pt idx="11">
                  <c:v>1.85392447108</c:v>
                </c:pt>
              </c:numCache>
            </c:numRef>
          </c:val>
        </c:ser>
        <c:ser>
          <c:idx val="6"/>
          <c:order val="6"/>
          <c:tx>
            <c:strRef>
              <c:f>Sheet3!$B$12</c:f>
              <c:strCache>
                <c:ptCount val="1"/>
                <c:pt idx="0">
                  <c:v>Othe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3!$C$5:$N$5</c:f>
              <c:strCache>
                <c:ptCount val="12"/>
                <c:pt idx="0">
                  <c:v>Control</c:v>
                </c:pt>
                <c:pt idx="1">
                  <c:v>EPS</c:v>
                </c:pt>
                <c:pt idx="2">
                  <c:v>EPS+N/P</c:v>
                </c:pt>
                <c:pt idx="3">
                  <c:v>Glc</c:v>
                </c:pt>
                <c:pt idx="4">
                  <c:v>Glc+N/P</c:v>
                </c:pt>
                <c:pt idx="5">
                  <c:v>EPS+Glc+N/P</c:v>
                </c:pt>
                <c:pt idx="6">
                  <c:v>Control</c:v>
                </c:pt>
                <c:pt idx="7">
                  <c:v>EPS</c:v>
                </c:pt>
                <c:pt idx="8">
                  <c:v>EPS+N/P</c:v>
                </c:pt>
                <c:pt idx="9">
                  <c:v>Glc</c:v>
                </c:pt>
                <c:pt idx="10">
                  <c:v>Glc+N/P</c:v>
                </c:pt>
                <c:pt idx="11">
                  <c:v>EPS+Glc+N/P</c:v>
                </c:pt>
              </c:strCache>
            </c:strRef>
          </c:cat>
          <c:val>
            <c:numRef>
              <c:f>Sheet3!$C$12:$N$12</c:f>
              <c:numCache>
                <c:formatCode>0.00_ </c:formatCode>
                <c:ptCount val="12"/>
                <c:pt idx="0">
                  <c:v>0.87632683288012</c:v>
                </c:pt>
                <c:pt idx="1">
                  <c:v>0.41401188267823</c:v>
                </c:pt>
                <c:pt idx="2">
                  <c:v>0.67711503347591</c:v>
                </c:pt>
                <c:pt idx="3">
                  <c:v>0.23616518797436</c:v>
                </c:pt>
                <c:pt idx="4">
                  <c:v>0.35662618174476</c:v>
                </c:pt>
                <c:pt idx="5">
                  <c:v>0.15257536697011</c:v>
                </c:pt>
                <c:pt idx="6">
                  <c:v>0.44667414790913</c:v>
                </c:pt>
                <c:pt idx="7">
                  <c:v>0.41165766787033</c:v>
                </c:pt>
                <c:pt idx="8">
                  <c:v>0.58465733312373</c:v>
                </c:pt>
                <c:pt idx="9">
                  <c:v>0.31253651127429</c:v>
                </c:pt>
                <c:pt idx="10">
                  <c:v>0.33257386447168</c:v>
                </c:pt>
                <c:pt idx="11">
                  <c:v>0.469347967362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06932760"/>
        <c:axId val="-2107099128"/>
      </c:barChart>
      <c:catAx>
        <c:axId val="-210693276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200" b="1">
                <a:latin typeface="Times New Roman"/>
                <a:cs typeface="Times New Roman"/>
              </a:defRPr>
            </a:pPr>
            <a:endParaRPr lang="zh-CN"/>
          </a:p>
        </c:txPr>
        <c:crossAx val="-2107099128"/>
        <c:crosses val="autoZero"/>
        <c:auto val="1"/>
        <c:lblAlgn val="ctr"/>
        <c:lblOffset val="100"/>
        <c:noMultiLvlLbl val="0"/>
      </c:catAx>
      <c:valAx>
        <c:axId val="-2107099128"/>
        <c:scaling>
          <c:orientation val="minMax"/>
        </c:scaling>
        <c:delete val="0"/>
        <c:axPos val="l"/>
        <c:numFmt formatCode="0%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/>
                <a:cs typeface="Times New Roman"/>
              </a:defRPr>
            </a:pPr>
            <a:endParaRPr lang="zh-CN"/>
          </a:p>
        </c:txPr>
        <c:crossAx val="-2106932760"/>
        <c:crosses val="autoZero"/>
        <c:crossBetween val="between"/>
        <c:majorUnit val="0.2"/>
        <c:minorUnit val="0.04"/>
      </c:valAx>
    </c:plotArea>
    <c:legend>
      <c:legendPos val="r"/>
      <c:layout/>
      <c:overlay val="0"/>
      <c:txPr>
        <a:bodyPr/>
        <a:lstStyle/>
        <a:p>
          <a:pPr>
            <a:defRPr sz="1200" b="1">
              <a:latin typeface="Times New Roman"/>
              <a:cs typeface="Times New Roman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6325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7751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78984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1041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34452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7492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84534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8823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34641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95604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4498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17131-06FB-9F41-B407-1F2F2231A8ED}" type="datetimeFigureOut">
              <a:rPr kumimoji="1" lang="zh-CN" altLang="en-US" smtClean="0"/>
              <a:t>15/10/19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2E193-B0F8-BB41-9384-05810C6C467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189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9"/>
          <p:cNvSpPr txBox="1"/>
          <p:nvPr/>
        </p:nvSpPr>
        <p:spPr>
          <a:xfrm>
            <a:off x="2625491" y="848791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zh-CN" dirty="0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2 day</a:t>
            </a:r>
            <a:endParaRPr lang="zh-CN" altLang="en-US" dirty="0">
              <a:solidFill>
                <a:prstClr val="black"/>
              </a:solidFill>
              <a:latin typeface="Times New Roman"/>
              <a:ea typeface="宋体"/>
              <a:cs typeface="Times New Roman"/>
            </a:endParaRPr>
          </a:p>
        </p:txBody>
      </p:sp>
      <p:sp>
        <p:nvSpPr>
          <p:cNvPr id="7" name="TextBox 40"/>
          <p:cNvSpPr txBox="1"/>
          <p:nvPr/>
        </p:nvSpPr>
        <p:spPr>
          <a:xfrm>
            <a:off x="4927874" y="848791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altLang="zh-CN" dirty="0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14 day</a:t>
            </a:r>
            <a:endParaRPr lang="zh-CN" altLang="en-US" dirty="0">
              <a:solidFill>
                <a:prstClr val="black"/>
              </a:solidFill>
              <a:latin typeface="Times New Roman"/>
              <a:ea typeface="宋体"/>
              <a:cs typeface="Times New Roman"/>
            </a:endParaRPr>
          </a:p>
        </p:txBody>
      </p:sp>
      <p:graphicFrame>
        <p:nvGraphicFramePr>
          <p:cNvPr id="9" name="图表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4619954"/>
              </p:ext>
            </p:extLst>
          </p:nvPr>
        </p:nvGraphicFramePr>
        <p:xfrm>
          <a:off x="1216024" y="1246202"/>
          <a:ext cx="7190195" cy="4579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1" name="直接连接符 38"/>
          <p:cNvCxnSpPr/>
          <p:nvPr/>
        </p:nvCxnSpPr>
        <p:spPr>
          <a:xfrm>
            <a:off x="1922469" y="1282801"/>
            <a:ext cx="20929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38"/>
          <p:cNvCxnSpPr/>
          <p:nvPr/>
        </p:nvCxnSpPr>
        <p:spPr>
          <a:xfrm>
            <a:off x="4283362" y="1282801"/>
            <a:ext cx="20929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0" y="42103"/>
            <a:ext cx="727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S2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Fig</a:t>
            </a:r>
            <a:endParaRPr kumimoji="1" lang="zh-CN" altLang="en-US" dirty="0"/>
          </a:p>
        </p:txBody>
      </p:sp>
      <p:sp>
        <p:nvSpPr>
          <p:cNvPr id="8" name="文本框 2"/>
          <p:cNvSpPr txBox="1">
            <a:spLocks noChangeArrowheads="1"/>
          </p:cNvSpPr>
          <p:nvPr/>
        </p:nvSpPr>
        <p:spPr bwMode="auto">
          <a:xfrm rot="16200000">
            <a:off x="220346" y="2852836"/>
            <a:ext cx="16426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 sz="1400" b="1" dirty="0">
                <a:latin typeface="Times New Roman"/>
                <a:cs typeface="Times New Roman"/>
              </a:rPr>
              <a:t>relative abundance</a:t>
            </a:r>
            <a:r>
              <a:rPr lang="zh-CN" altLang="zh-CN" sz="1400" b="1" dirty="0" smtClean="0">
                <a:effectLst/>
                <a:latin typeface="Times New Roman"/>
                <a:cs typeface="Times New Roman"/>
              </a:rPr>
              <a:t> </a:t>
            </a:r>
            <a:endParaRPr lang="zh-CN" altLang="en-US" sz="14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57859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8</Words>
  <Application>Microsoft Macintosh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XM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</dc:creator>
  <cp:lastModifiedBy>张</cp:lastModifiedBy>
  <cp:revision>5</cp:revision>
  <dcterms:created xsi:type="dcterms:W3CDTF">2015-10-13T07:06:11Z</dcterms:created>
  <dcterms:modified xsi:type="dcterms:W3CDTF">2015-10-19T08:14:21Z</dcterms:modified>
</cp:coreProperties>
</file>